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74" autoAdjust="0"/>
    <p:restoredTop sz="94660"/>
  </p:normalViewPr>
  <p:slideViewPr>
    <p:cSldViewPr snapToGrid="0">
      <p:cViewPr varScale="1">
        <p:scale>
          <a:sx n="60" d="100"/>
          <a:sy n="60" d="100"/>
        </p:scale>
        <p:origin x="72" y="10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D0401-FC7C-4B6A-B9BE-1CAFE9E2681E}" type="datetimeFigureOut">
              <a:rPr lang="en-US" smtClean="0"/>
              <a:t>2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9719B-D758-4557-9944-FE3926C9D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9497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D0401-FC7C-4B6A-B9BE-1CAFE9E2681E}" type="datetimeFigureOut">
              <a:rPr lang="en-US" smtClean="0"/>
              <a:t>2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9719B-D758-4557-9944-FE3926C9D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65423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D0401-FC7C-4B6A-B9BE-1CAFE9E2681E}" type="datetimeFigureOut">
              <a:rPr lang="en-US" smtClean="0"/>
              <a:t>2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9719B-D758-4557-9944-FE3926C9D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69990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D0401-FC7C-4B6A-B9BE-1CAFE9E2681E}" type="datetimeFigureOut">
              <a:rPr lang="en-US" smtClean="0"/>
              <a:t>2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9719B-D758-4557-9944-FE3926C9D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09858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D0401-FC7C-4B6A-B9BE-1CAFE9E2681E}" type="datetimeFigureOut">
              <a:rPr lang="en-US" smtClean="0"/>
              <a:t>2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9719B-D758-4557-9944-FE3926C9D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04650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D0401-FC7C-4B6A-B9BE-1CAFE9E2681E}" type="datetimeFigureOut">
              <a:rPr lang="en-US" smtClean="0"/>
              <a:t>2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9719B-D758-4557-9944-FE3926C9D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59680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D0401-FC7C-4B6A-B9BE-1CAFE9E2681E}" type="datetimeFigureOut">
              <a:rPr lang="en-US" smtClean="0"/>
              <a:t>2/21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9719B-D758-4557-9944-FE3926C9D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96398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D0401-FC7C-4B6A-B9BE-1CAFE9E2681E}" type="datetimeFigureOut">
              <a:rPr lang="en-US" smtClean="0"/>
              <a:t>2/21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9719B-D758-4557-9944-FE3926C9D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44261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D0401-FC7C-4B6A-B9BE-1CAFE9E2681E}" type="datetimeFigureOut">
              <a:rPr lang="en-US" smtClean="0"/>
              <a:t>2/21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9719B-D758-4557-9944-FE3926C9D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95324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D0401-FC7C-4B6A-B9BE-1CAFE9E2681E}" type="datetimeFigureOut">
              <a:rPr lang="en-US" smtClean="0"/>
              <a:t>2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9719B-D758-4557-9944-FE3926C9D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60197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D0401-FC7C-4B6A-B9BE-1CAFE9E2681E}" type="datetimeFigureOut">
              <a:rPr lang="en-US" smtClean="0"/>
              <a:t>2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9719B-D758-4557-9944-FE3926C9D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39790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2D0401-FC7C-4B6A-B9BE-1CAFE9E2681E}" type="datetimeFigureOut">
              <a:rPr lang="en-US" smtClean="0"/>
              <a:t>2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A9719B-D758-4557-9944-FE3926C9D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15796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0E64CE73-BABD-461F-8552-14C2B9B42E50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742380503"/>
              </p:ext>
            </p:extLst>
          </p:nvPr>
        </p:nvGraphicFramePr>
        <p:xfrm>
          <a:off x="336885" y="401052"/>
          <a:ext cx="11389894" cy="6272462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3624722">
                  <a:extLst>
                    <a:ext uri="{9D8B030D-6E8A-4147-A177-3AD203B41FA5}">
                      <a16:colId xmlns:a16="http://schemas.microsoft.com/office/drawing/2014/main" val="4144738971"/>
                    </a:ext>
                  </a:extLst>
                </a:gridCol>
                <a:gridCol w="2629786">
                  <a:extLst>
                    <a:ext uri="{9D8B030D-6E8A-4147-A177-3AD203B41FA5}">
                      <a16:colId xmlns:a16="http://schemas.microsoft.com/office/drawing/2014/main" val="3458812486"/>
                    </a:ext>
                  </a:extLst>
                </a:gridCol>
                <a:gridCol w="2498296">
                  <a:extLst>
                    <a:ext uri="{9D8B030D-6E8A-4147-A177-3AD203B41FA5}">
                      <a16:colId xmlns:a16="http://schemas.microsoft.com/office/drawing/2014/main" val="982915751"/>
                    </a:ext>
                  </a:extLst>
                </a:gridCol>
                <a:gridCol w="2637090">
                  <a:extLst>
                    <a:ext uri="{9D8B030D-6E8A-4147-A177-3AD203B41FA5}">
                      <a16:colId xmlns:a16="http://schemas.microsoft.com/office/drawing/2014/main" val="612333436"/>
                    </a:ext>
                  </a:extLst>
                </a:gridCol>
              </a:tblGrid>
              <a:tr h="120823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kern="1800">
                          <a:effectLst/>
                        </a:rPr>
                        <a:t>Methods</a:t>
                      </a:r>
                      <a:endParaRPr lang="en-US" sz="2800">
                        <a:effectLst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kern="1800">
                          <a:effectLst/>
                        </a:rPr>
                        <a:t>Time (Minutes)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kern="1800">
                          <a:effectLst/>
                        </a:rPr>
                        <a:t>Manual</a:t>
                      </a:r>
                      <a:endParaRPr lang="en-US" sz="2800">
                        <a:effectLst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kern="1800">
                          <a:effectLst/>
                        </a:rPr>
                        <a:t> 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kern="1800">
                          <a:effectLst/>
                        </a:rPr>
                        <a:t>Android</a:t>
                      </a:r>
                      <a:endParaRPr lang="en-US" sz="2800">
                        <a:effectLst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kern="1800">
                          <a:effectLst/>
                        </a:rPr>
                        <a:t> 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kern="1800">
                          <a:effectLst/>
                        </a:rPr>
                        <a:t>IOS </a:t>
                      </a:r>
                      <a:endParaRPr lang="en-US" sz="2800">
                        <a:effectLst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kern="1800">
                          <a:effectLst/>
                        </a:rPr>
                        <a:t> 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796262243"/>
                  </a:ext>
                </a:extLst>
              </a:tr>
              <a:tr h="103994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kern="1800">
                          <a:effectLst/>
                        </a:rPr>
                        <a:t>Data entry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kern="1800" dirty="0">
                          <a:effectLst/>
                        </a:rPr>
                        <a:t>132</a:t>
                      </a:r>
                      <a:endParaRPr lang="en-US" sz="2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kern="1800">
                          <a:effectLst/>
                        </a:rPr>
                        <a:t>132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kern="1800">
                          <a:effectLst/>
                        </a:rPr>
                        <a:t>132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647579709"/>
                  </a:ext>
                </a:extLst>
              </a:tr>
              <a:tr h="1006073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kern="1800">
                          <a:effectLst/>
                        </a:rPr>
                        <a:t>Data transferring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kern="1800">
                          <a:effectLst/>
                        </a:rPr>
                        <a:t>95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kern="1800">
                          <a:effectLst/>
                        </a:rPr>
                        <a:t>-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kern="1800">
                          <a:effectLst/>
                        </a:rPr>
                        <a:t>-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249870038"/>
                  </a:ext>
                </a:extLst>
              </a:tr>
              <a:tr h="1006073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kern="1800">
                          <a:effectLst/>
                        </a:rPr>
                        <a:t>Data cleaning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kern="1800">
                          <a:effectLst/>
                        </a:rPr>
                        <a:t>63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kern="1800">
                          <a:effectLst/>
                        </a:rPr>
                        <a:t>-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kern="1800">
                          <a:effectLst/>
                        </a:rPr>
                        <a:t>-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623708516"/>
                  </a:ext>
                </a:extLst>
              </a:tr>
              <a:tr h="1006073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kern="1800">
                          <a:effectLst/>
                        </a:rPr>
                        <a:t>Data summarizing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kern="1800">
                          <a:effectLst/>
                        </a:rPr>
                        <a:t>25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kern="1800">
                          <a:effectLst/>
                        </a:rPr>
                        <a:t>1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kern="1800">
                          <a:effectLst/>
                        </a:rPr>
                        <a:t>1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120516009"/>
                  </a:ext>
                </a:extLst>
              </a:tr>
              <a:tr h="1006073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kern="1800">
                          <a:effectLst/>
                        </a:rPr>
                        <a:t>Total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kern="1800">
                          <a:effectLst/>
                        </a:rPr>
                        <a:t>315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kern="1800">
                          <a:effectLst/>
                        </a:rPr>
                        <a:t>133</a:t>
                      </a:r>
                      <a:endParaRPr lang="en-US" sz="2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800" kern="1800" dirty="0">
                          <a:effectLst/>
                        </a:rPr>
                        <a:t>133</a:t>
                      </a:r>
                      <a:endParaRPr lang="en-US" sz="2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97369368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957799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</TotalTime>
  <Words>35</Words>
  <Application>Microsoft Office PowerPoint</Application>
  <PresentationFormat>Widescreen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ordia New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account</dc:creator>
  <cp:lastModifiedBy>Pagaporn Pantuwadee</cp:lastModifiedBy>
  <cp:revision>5</cp:revision>
  <dcterms:created xsi:type="dcterms:W3CDTF">2024-01-08T18:37:38Z</dcterms:created>
  <dcterms:modified xsi:type="dcterms:W3CDTF">2024-02-21T06:52:19Z</dcterms:modified>
</cp:coreProperties>
</file>